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7053263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2160" y="12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55938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95738" y="0"/>
            <a:ext cx="3055937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48864D-A3F7-4755-A370-676BBC26D579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98500"/>
            <a:ext cx="2619375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4850" y="4421188"/>
            <a:ext cx="5643563" cy="4189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375"/>
            <a:ext cx="3055938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95738" y="8842375"/>
            <a:ext cx="3055937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56677D-E225-4DE3-A1C8-A701FE04A2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260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E56677D-E225-4DE3-A1C8-A701FE04A2D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062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255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677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185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060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317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046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744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879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287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159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398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F29ED2-C068-479E-94C1-8BD62D01C628}" type="datetimeFigureOut">
              <a:rPr lang="en-US" smtClean="0"/>
              <a:t>9/2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6CB934-B0A3-487D-9A4D-64AEBA2BA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738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43729" y="1397678"/>
            <a:ext cx="4522906" cy="6555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ALP-For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GTCTCCATGGTGGACTATGCT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ALP-Rev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GACGTAGTTCTGCTCGTGGA-3’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				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BMP-1-For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TCTGACGGGTCCATTAACAAA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BMP-1-Rev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CGTTGAGCTTGGTGAGGAAT-3’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	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BMP-2-For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CAGACCACCGGTTGGAGA-3’ 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BMP-2-Rev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AAGAAGAATCTCCGGGTTGTTT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BMP-6-For 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GCGACACCACAACGAGTTCA-3’ 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BMP-6-Rev 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AAATTCCAGCCAGCCAGCCTTCTT-3’  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	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BMP-7-For 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TGGCTGGTGTGTTTGACATCAC-3’</a:t>
            </a:r>
            <a:endParaRPr lang="en-US" sz="1000" dirty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BMP-7-Rev 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CATGAAGGGCTGCTTGTTCT-3’ 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RUNX2-For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ATTTAGGGCGCATTCCTCAT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RUNX2-Rev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CGTCATCTGGCTCAGGTAGG-3’</a:t>
            </a:r>
            <a:endParaRPr lang="en-US" sz="1000" dirty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	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COL</a:t>
            </a:r>
            <a:r>
              <a:rPr lang="el-GR" sz="1000" dirty="0" smtClean="0">
                <a:latin typeface="Courier New" pitchFamily="49" charset="0"/>
                <a:cs typeface="Courier New" pitchFamily="49" charset="0"/>
              </a:rPr>
              <a:t>α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1-For 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AGGGAGAGCCTGGAGATGAC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COL</a:t>
            </a:r>
            <a:r>
              <a:rPr lang="el-GR" sz="1000" dirty="0" smtClean="0">
                <a:latin typeface="Courier New" pitchFamily="49" charset="0"/>
                <a:cs typeface="Courier New" pitchFamily="49" charset="0"/>
              </a:rPr>
              <a:t>α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1-Rev 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GGAATCCTCTCTCACCACGTT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DMP1-For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CCCTTGGAGAGCAGTGAGTC-3’ </a:t>
            </a:r>
            <a:endParaRPr lang="en-US" sz="1000" dirty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DMP1-Rev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CTCCTTTTCCTGTGCTCCTG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DSPP-For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TGCATTTGGGCAGTAGCAT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DSPP-Rev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TGTCTCTCCAGTGGTTTGCTT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DLX3-For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TACTCGCCCAAGTCGGAATA-3’ 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DLX3-Rev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TCTTGGGCTTCCCATTCA-3’</a:t>
            </a:r>
            <a:endParaRPr lang="en-US" sz="1000" dirty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	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LIF-For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TGCCAATGCCCTCTTTATTC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LIF-Rev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GCCACATAGCTTGTCCAGGT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endParaRPr lang="en-US" sz="1000" dirty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OPG-For 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GGAAATGCAACACACGACAA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OPG-Rev 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            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TACTTTGGTGCCAGGCAAATT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endParaRPr lang="en-US" sz="1000" dirty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OC-For 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ACCCAGGCGCTACCTGTAT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OC-Rev 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AGCAGAGCGACACCCTAGAC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endParaRPr lang="en-US" sz="1000" dirty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OSX-For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CATCTGCCTGGCTCCTTG-3’</a:t>
            </a:r>
            <a:endParaRPr lang="en-US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OSX-Rev</a:t>
            </a:r>
            <a:r>
              <a:rPr lang="en-US" sz="1000" dirty="0">
                <a:latin typeface="Courier New" pitchFamily="49" charset="0"/>
                <a:cs typeface="Courier New" pitchFamily="49" charset="0"/>
              </a:rPr>
              <a:t>		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5’-GGGACTGGAGCCATAGTGAA-3’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	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		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1322792" y="949856"/>
            <a:ext cx="440461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496894" y="623689"/>
            <a:ext cx="4068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able 1. Primers used for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-PCR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" name="Straight Connector 8"/>
          <p:cNvCxnSpPr/>
          <p:nvPr/>
        </p:nvCxnSpPr>
        <p:spPr>
          <a:xfrm>
            <a:off x="1322792" y="7797223"/>
            <a:ext cx="440461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1311359" y="1320223"/>
            <a:ext cx="440461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1558033" y="1007787"/>
            <a:ext cx="527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Gene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60964" y="1000692"/>
            <a:ext cx="1283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Primer sequence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97887" y="7853580"/>
            <a:ext cx="4242682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LP, Alkaline phosphatase;  BMP, Bone morphogenetic protein; Col</a:t>
            </a:r>
            <a:r>
              <a:rPr lang="el-GR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, Alpha 1 collagen alpha 1; DMP1, Dent</a:t>
            </a:r>
            <a:r>
              <a:rPr lang="en-US" sz="11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n matrix protein 1; DSPP, Dentin </a:t>
            </a:r>
            <a:r>
              <a:rPr lang="en-US" sz="11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ialophosphoprotein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  DLX3, Distal-less-3 ;  LIF; Leukemia inhibitory factor;  OPG, </a:t>
            </a:r>
            <a:r>
              <a:rPr lang="en-US" sz="11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teoprotegerin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1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c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1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teocalcin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100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x</a:t>
            </a:r>
            <a:r>
              <a:rPr lang="en-US" sz="11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1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sterix</a:t>
            </a:r>
            <a:r>
              <a:rPr lang="en-US" sz="11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4125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</TotalTime>
  <Words>68</Words>
  <Application>Microsoft Office PowerPoint</Application>
  <PresentationFormat>On-screen Show (4:3)</PresentationFormat>
  <Paragraphs>4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6</cp:revision>
  <cp:lastPrinted>2013-09-27T16:19:11Z</cp:lastPrinted>
  <dcterms:created xsi:type="dcterms:W3CDTF">2012-11-19T03:17:06Z</dcterms:created>
  <dcterms:modified xsi:type="dcterms:W3CDTF">2013-09-28T14:33:43Z</dcterms:modified>
</cp:coreProperties>
</file>